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7" r:id="rId3"/>
    <p:sldId id="268" r:id="rId4"/>
    <p:sldId id="270" r:id="rId5"/>
    <p:sldId id="259" r:id="rId6"/>
    <p:sldId id="260" r:id="rId7"/>
  </p:sldIdLst>
  <p:sldSz cx="12192000" cy="6858000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68" d="100"/>
          <a:sy n="68" d="100"/>
        </p:scale>
        <p:origin x="7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tefano\Documents\Prangos_paper\Prango%20final%20table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B$1</c:f>
              <c:strCache>
                <c:ptCount val="1"/>
                <c:pt idx="0">
                  <c:v> P. heyniae- Hexane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3D9-40F1-8423-7C8E2DA983E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3D9-40F1-8423-7C8E2DA983E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3D9-40F1-8423-7C8E2DA983E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3D9-40F1-8423-7C8E2DA983E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3D9-40F1-8423-7C8E2DA983E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3D9-40F1-8423-7C8E2DA983EA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B$2:$B$7</c:f>
              <c:numCache>
                <c:formatCode>General</c:formatCode>
                <c:ptCount val="6"/>
                <c:pt idx="0">
                  <c:v>0.24000000000000005</c:v>
                </c:pt>
                <c:pt idx="1">
                  <c:v>0</c:v>
                </c:pt>
                <c:pt idx="2">
                  <c:v>7.0000000000000007E-2</c:v>
                </c:pt>
                <c:pt idx="3">
                  <c:v>0</c:v>
                </c:pt>
                <c:pt idx="4">
                  <c:v>1.83</c:v>
                </c:pt>
                <c:pt idx="5">
                  <c:v>8.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73D9-40F1-8423-7C8E2DA983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K$1</c:f>
              <c:strCache>
                <c:ptCount val="1"/>
                <c:pt idx="0">
                  <c:v> P. uechtritzii-EA 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406-4802-A7F0-7FF2B15A358D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406-4802-A7F0-7FF2B15A358D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406-4802-A7F0-7FF2B15A358D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406-4802-A7F0-7FF2B15A358D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406-4802-A7F0-7FF2B15A358D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406-4802-A7F0-7FF2B15A358D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K$2:$K$7</c:f>
              <c:numCache>
                <c:formatCode>General</c:formatCode>
                <c:ptCount val="6"/>
                <c:pt idx="0">
                  <c:v>5.09</c:v>
                </c:pt>
                <c:pt idx="1">
                  <c:v>0</c:v>
                </c:pt>
                <c:pt idx="2">
                  <c:v>1.6400000000000001</c:v>
                </c:pt>
                <c:pt idx="3">
                  <c:v>2.68</c:v>
                </c:pt>
                <c:pt idx="4">
                  <c:v>0</c:v>
                </c:pt>
                <c:pt idx="5">
                  <c:v>9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406-4802-A7F0-7FF2B15A35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L$1</c:f>
              <c:strCache>
                <c:ptCount val="1"/>
                <c:pt idx="0">
                  <c:v> P. uechtritzii-MeOH 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55B-4DBD-BDBA-396977ED010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55B-4DBD-BDBA-396977ED010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55B-4DBD-BDBA-396977ED010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55B-4DBD-BDBA-396977ED010C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55B-4DBD-BDBA-396977ED010C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355B-4DBD-BDBA-396977ED010C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L$2:$L$7</c:f>
              <c:numCache>
                <c:formatCode>General</c:formatCode>
                <c:ptCount val="6"/>
                <c:pt idx="0">
                  <c:v>53.74</c:v>
                </c:pt>
                <c:pt idx="1">
                  <c:v>0</c:v>
                </c:pt>
                <c:pt idx="2">
                  <c:v>25.59</c:v>
                </c:pt>
                <c:pt idx="3">
                  <c:v>138.03</c:v>
                </c:pt>
                <c:pt idx="4">
                  <c:v>6.27</c:v>
                </c:pt>
                <c:pt idx="5">
                  <c:v>25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355B-4DBD-BDBA-396977ED01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M$1</c:f>
              <c:strCache>
                <c:ptCount val="1"/>
                <c:pt idx="0">
                  <c:v> P. uechtritzii-Water 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F6A-4075-B042-20AB73F0AAD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F6A-4075-B042-20AB73F0AAD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F6A-4075-B042-20AB73F0AAD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F6A-4075-B042-20AB73F0AADC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F6A-4075-B042-20AB73F0AADC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F6A-4075-B042-20AB73F0AADC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M$2:$M$7</c:f>
              <c:numCache>
                <c:formatCode>General</c:formatCode>
                <c:ptCount val="6"/>
                <c:pt idx="0">
                  <c:v>31.49</c:v>
                </c:pt>
                <c:pt idx="1">
                  <c:v>0</c:v>
                </c:pt>
                <c:pt idx="2">
                  <c:v>28.05</c:v>
                </c:pt>
                <c:pt idx="3">
                  <c:v>48.92</c:v>
                </c:pt>
                <c:pt idx="4">
                  <c:v>4.6900000000000004</c:v>
                </c:pt>
                <c:pt idx="5">
                  <c:v>16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9F6A-4075-B042-20AB73F0AA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C$1</c:f>
              <c:strCache>
                <c:ptCount val="1"/>
                <c:pt idx="0">
                  <c:v> P. heyniae- EA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4DD-41A9-80EE-02EF12FDB229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4DD-41A9-80EE-02EF12FDB229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4DD-41A9-80EE-02EF12FDB229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4DD-41A9-80EE-02EF12FDB229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4DD-41A9-80EE-02EF12FDB229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4DD-41A9-80EE-02EF12FDB229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C$2:$C$7</c:f>
              <c:numCache>
                <c:formatCode>General</c:formatCode>
                <c:ptCount val="6"/>
                <c:pt idx="0">
                  <c:v>17.12</c:v>
                </c:pt>
                <c:pt idx="1">
                  <c:v>0</c:v>
                </c:pt>
                <c:pt idx="2">
                  <c:v>0.04</c:v>
                </c:pt>
                <c:pt idx="3">
                  <c:v>0</c:v>
                </c:pt>
                <c:pt idx="4">
                  <c:v>5.6400000000000006</c:v>
                </c:pt>
                <c:pt idx="5">
                  <c:v>7.22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A4DD-41A9-80EE-02EF12FDB2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D$1</c:f>
              <c:strCache>
                <c:ptCount val="1"/>
                <c:pt idx="0">
                  <c:v>P. heyniae- MeOH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DE7-4E19-8D01-E336577D0F30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DE7-4E19-8D01-E336577D0F30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DE7-4E19-8D01-E336577D0F30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DE7-4E19-8D01-E336577D0F30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DE7-4E19-8D01-E336577D0F30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DE7-4E19-8D01-E336577D0F30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D$2:$D$7</c:f>
              <c:numCache>
                <c:formatCode>General</c:formatCode>
                <c:ptCount val="6"/>
                <c:pt idx="0">
                  <c:v>141.94999999999999</c:v>
                </c:pt>
                <c:pt idx="1">
                  <c:v>4.5600000000000005</c:v>
                </c:pt>
                <c:pt idx="2">
                  <c:v>4.18</c:v>
                </c:pt>
                <c:pt idx="3">
                  <c:v>0</c:v>
                </c:pt>
                <c:pt idx="4">
                  <c:v>9.26</c:v>
                </c:pt>
                <c:pt idx="5">
                  <c:v>25.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DE7-4E19-8D01-E336577D0F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E$1</c:f>
              <c:strCache>
                <c:ptCount val="1"/>
                <c:pt idx="0">
                  <c:v>P. heyniae- Water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37A-4A72-80C2-FC6B6EE0200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37A-4A72-80C2-FC6B6EE0200B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37A-4A72-80C2-FC6B6EE0200B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37A-4A72-80C2-FC6B6EE0200B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37A-4A72-80C2-FC6B6EE0200B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37A-4A72-80C2-FC6B6EE0200B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E$2:$E$7</c:f>
              <c:numCache>
                <c:formatCode>General</c:formatCode>
                <c:ptCount val="6"/>
                <c:pt idx="0">
                  <c:v>103.76999999999998</c:v>
                </c:pt>
                <c:pt idx="1">
                  <c:v>3.8200000000000003</c:v>
                </c:pt>
                <c:pt idx="2">
                  <c:v>9.1</c:v>
                </c:pt>
                <c:pt idx="3">
                  <c:v>0</c:v>
                </c:pt>
                <c:pt idx="4">
                  <c:v>7.6099999999999994</c:v>
                </c:pt>
                <c:pt idx="5">
                  <c:v>25.7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37A-4A72-80C2-FC6B6EE020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F$1</c:f>
              <c:strCache>
                <c:ptCount val="1"/>
                <c:pt idx="0">
                  <c:v>P. meliocarpoides- Hexane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98B-4E1D-840C-717606A901A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98B-4E1D-840C-717606A901A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98B-4E1D-840C-717606A901A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98B-4E1D-840C-717606A901A8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98B-4E1D-840C-717606A901A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98B-4E1D-840C-717606A901A8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F$2:$F$7</c:f>
              <c:numCache>
                <c:formatCode>General</c:formatCode>
                <c:ptCount val="6"/>
                <c:pt idx="0">
                  <c:v>1.29</c:v>
                </c:pt>
                <c:pt idx="1">
                  <c:v>41.289999999999992</c:v>
                </c:pt>
                <c:pt idx="2">
                  <c:v>0.94</c:v>
                </c:pt>
                <c:pt idx="3">
                  <c:v>6.1</c:v>
                </c:pt>
                <c:pt idx="4">
                  <c:v>0.14000000000000001</c:v>
                </c:pt>
                <c:pt idx="5">
                  <c:v>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198B-4E1D-840C-717606A901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G$1</c:f>
              <c:strCache>
                <c:ptCount val="1"/>
                <c:pt idx="0">
                  <c:v> P. meliocarpoides-EA 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761-403F-8442-6A5729128FC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761-403F-8442-6A5729128FC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761-403F-8442-6A5729128FC3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761-403F-8442-6A5729128FC3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761-403F-8442-6A5729128FC3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761-403F-8442-6A5729128FC3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G$2:$G$7</c:f>
              <c:numCache>
                <c:formatCode>General</c:formatCode>
                <c:ptCount val="6"/>
                <c:pt idx="0">
                  <c:v>2.1500000000000004</c:v>
                </c:pt>
                <c:pt idx="1">
                  <c:v>55.519999999999996</c:v>
                </c:pt>
                <c:pt idx="2">
                  <c:v>0.43000000000000005</c:v>
                </c:pt>
                <c:pt idx="3">
                  <c:v>5.19</c:v>
                </c:pt>
                <c:pt idx="4">
                  <c:v>1.46</c:v>
                </c:pt>
                <c:pt idx="5">
                  <c:v>1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8761-403F-8442-6A5729128F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H$1</c:f>
              <c:strCache>
                <c:ptCount val="1"/>
                <c:pt idx="0">
                  <c:v> P. meliocarpoides-MeOH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249-4F71-94E3-DF8ACE08E749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249-4F71-94E3-DF8ACE08E749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249-4F71-94E3-DF8ACE08E749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249-4F71-94E3-DF8ACE08E749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249-4F71-94E3-DF8ACE08E749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249-4F71-94E3-DF8ACE08E749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H$2:$H$7</c:f>
              <c:numCache>
                <c:formatCode>General</c:formatCode>
                <c:ptCount val="6"/>
                <c:pt idx="0">
                  <c:v>2.9699999999999998</c:v>
                </c:pt>
                <c:pt idx="1">
                  <c:v>204.04000000000002</c:v>
                </c:pt>
                <c:pt idx="2">
                  <c:v>16.509999999999998</c:v>
                </c:pt>
                <c:pt idx="3">
                  <c:v>83.65</c:v>
                </c:pt>
                <c:pt idx="4">
                  <c:v>3.07</c:v>
                </c:pt>
                <c:pt idx="5">
                  <c:v>43.01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249-4F71-94E3-DF8ACE08E7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I$1</c:f>
              <c:strCache>
                <c:ptCount val="1"/>
                <c:pt idx="0">
                  <c:v> P. meliocarpoides-Water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9A4-4E58-9A51-2204FE5CBAF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9A4-4E58-9A51-2204FE5CBAFB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9A4-4E58-9A51-2204FE5CBAFB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9A4-4E58-9A51-2204FE5CBAFB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9A4-4E58-9A51-2204FE5CBAFB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9A4-4E58-9A51-2204FE5CBAFB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I$2:$I$7</c:f>
              <c:numCache>
                <c:formatCode>General</c:formatCode>
                <c:ptCount val="6"/>
                <c:pt idx="0">
                  <c:v>4.7299999999999995</c:v>
                </c:pt>
                <c:pt idx="1">
                  <c:v>251.9</c:v>
                </c:pt>
                <c:pt idx="2">
                  <c:v>22.82</c:v>
                </c:pt>
                <c:pt idx="3">
                  <c:v>47.62</c:v>
                </c:pt>
                <c:pt idx="4">
                  <c:v>0.77</c:v>
                </c:pt>
                <c:pt idx="5">
                  <c:v>18.91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9A4-4E58-9A51-2204FE5CBA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Foglio2!$J$1</c:f>
              <c:strCache>
                <c:ptCount val="1"/>
                <c:pt idx="0">
                  <c:v> P. uechtritzii-Hexane 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B1A-4FCA-92A1-523205E2FFC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B1A-4FCA-92A1-523205E2FFC1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B1A-4FCA-92A1-523205E2FFC1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B1A-4FCA-92A1-523205E2FFC1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B1A-4FCA-92A1-523205E2FFC1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B1A-4FCA-92A1-523205E2FFC1}"/>
              </c:ext>
            </c:extLst>
          </c:dPt>
          <c:cat>
            <c:strRef>
              <c:f>Foglio2!$A$2:$A$7</c:f>
              <c:strCache>
                <c:ptCount val="6"/>
                <c:pt idx="0">
                  <c:v>Condensed tannins</c:v>
                </c:pt>
                <c:pt idx="1">
                  <c:v>Hydrolisable tannins</c:v>
                </c:pt>
                <c:pt idx="2">
                  <c:v>Coumarins</c:v>
                </c:pt>
                <c:pt idx="3">
                  <c:v>Flavonoids</c:v>
                </c:pt>
                <c:pt idx="4">
                  <c:v>Hydroxycinnamic</c:v>
                </c:pt>
                <c:pt idx="5">
                  <c:v>Other compounds</c:v>
                </c:pt>
              </c:strCache>
            </c:strRef>
          </c:cat>
          <c:val>
            <c:numRef>
              <c:f>Foglio2!$J$2:$J$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4.12</c:v>
                </c:pt>
                <c:pt idx="3">
                  <c:v>0</c:v>
                </c:pt>
                <c:pt idx="4">
                  <c:v>0</c:v>
                </c:pt>
                <c:pt idx="5">
                  <c:v>2.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7B1A-4FCA-92A1-523205E2FF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AC26803-50BD-423C-BFE3-C9439A1407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E830DAC-8A6A-49BB-9D8E-B997881982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E26DDEA-CE27-42C0-A6BA-0E4E9EA4E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37E3EF4-42A8-4D9E-A273-B70ABD105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239633E-DB5E-4262-9C3B-2F6EA4490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0125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DC760DD-DA2A-4C70-99D2-548B434BD4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3917DB1-C9FF-4F0F-8690-26EF2DABC7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58BC1F8-E75C-46D7-BD70-495BEB9CC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B89BC71-8B04-42C6-BE11-BA87A06C7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C50B73E-A085-42A9-BEBC-D28C3A418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9846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348160C-9202-4E86-BE47-563E4C9FBB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3F8F369-E9B3-4BB5-B181-974214E776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2E03361-C40C-43D8-AB3B-B7A180686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40C1BA3-C06E-410E-A35A-968D1AD07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B95C2FE-AEA0-4F46-AB20-3A26A0BCC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4579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3E03D49-F4EB-4861-8BEA-83AA8CF3B4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FAFE050-1E5F-4C10-B7EF-E8B753A4C4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A58A880-42FA-4DCD-8D68-150760345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07CEEB3-4763-48C0-96F6-4D2A42C2F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26C7BF1-169C-4275-9B69-353CFD0FE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5062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82B55F-9C5C-4B78-84B1-788BA66E39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58CAC85-C6D0-43FE-A754-0D4CA80B16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D3A7C30-F0CF-45CF-A17D-CD9980333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175D834-F00B-4D0B-B6D0-66F90DBBB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4C60622-6F86-405A-A200-586069FBB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7549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065D163-420E-413F-A132-D340C1229A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D9216F0-EEE9-47C2-9075-4000B11CAA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E6449BE-B1C1-4D5A-8573-283830A92A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F0A8C90-F2DE-4CD4-8491-F6C02BCF1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2F169E7-83DA-487C-9C6B-366E02B145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8570E25-2255-4514-BA7A-14B3DF2D0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6031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1ED8BA4-B7B4-42DC-AE27-E8B8D9164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ACA6372-1ABB-4D28-90B9-F6FF3A98A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D5D5896-C48E-4BF6-AD93-1576F824EA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77551D6-F406-4B47-81E7-52BA4D9684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D0F25D0-5BC7-4F2A-8211-127B19FA16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C50E41E-2E46-48F4-8AE2-9AFB51367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67C6D02-C989-4FF8-84ED-F3C9BA507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1C66033-420C-40B3-BC03-D22D91A63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6258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F874D10-CDFB-4A50-9611-32506984C5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226922B-2C8B-4900-93E0-050E2C466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8B00B6F-F9CB-4F0C-BA0A-8D368F1DC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5C01507-5DEF-4630-87EB-F743CEC49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2838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0A3BC00-ACC9-47F5-A894-646F90072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91500B5-4995-4218-8F30-944F81E4E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B9A164F-7C22-4478-AC7D-0371132A9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621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EF4CA4-DDF8-431D-9D90-1F8FDCEBC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187FBC6-C040-42AE-A19D-B965693A9C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31DFF60-9F7D-4EBC-8644-14C12E70F6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CF6F947-E73B-4603-8DF2-6E74121BF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ACD7E70-187F-4E23-B887-BA7A77282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9B35B40-BEA5-4A47-888B-88A53E804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0587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CBCE29-8ECD-4FB1-A1BB-228FEDDD86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FAE7099-41B1-4F85-AD65-E5C0259F20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8412713-F6CE-4D64-8429-A3D68407F1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AF97D32-C25F-4A0E-BEB4-330E26F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69446C9-CCC3-42A7-AAD9-5D9D4B1D7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5CF86A1-1E38-4902-835F-D18C5DFF6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10727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FE2ED2B-7C78-4824-95AB-4736A44FD2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ED02683-FDB2-4F00-AAE4-A57EFF4DC2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870EE8F-3A79-42B2-82F5-F1299FFC75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D95C26-225D-4591-8D43-72EEF8F8D253}" type="datetimeFigureOut">
              <a:rPr lang="it-IT" smtClean="0"/>
              <a:t>01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413CF05-40A5-4B41-9FA0-869C543637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AF918AB-E0BA-4ED9-9E97-16D1C8FA0E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EC53E1-C76E-4236-9D48-C79C4F40342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3782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309E9E5-0D93-4A14-90CF-CF5B64ECB6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79990" y="508905"/>
            <a:ext cx="9144000" cy="2387600"/>
          </a:xfrm>
        </p:spPr>
        <p:txBody>
          <a:bodyPr>
            <a:normAutofit/>
          </a:bodyPr>
          <a:lstStyle/>
          <a:p>
            <a:pPr algn="l">
              <a:spcBef>
                <a:spcPts val="1200"/>
              </a:spcBef>
            </a:pPr>
            <a:r>
              <a:rPr lang="en-US" sz="20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ticle</a:t>
            </a:r>
            <a:br>
              <a:rPr lang="it-IT" sz="32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7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ytochemical screening, antioxidant, and enzyme inhibitory properties of three </a:t>
            </a:r>
            <a:r>
              <a:rPr lang="en-US" sz="27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angos</a:t>
            </a:r>
            <a:r>
              <a:rPr lang="en-US" sz="27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pecies (</a:t>
            </a:r>
            <a:r>
              <a:rPr lang="en-US" sz="27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heyniae, P. meliocarpoides</a:t>
            </a:r>
            <a:r>
              <a:rPr lang="en-US" sz="27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r. </a:t>
            </a:r>
            <a:r>
              <a:rPr lang="en-US" sz="27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liocarpoides</a:t>
            </a:r>
            <a:r>
              <a:rPr lang="en-US" sz="27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</a:t>
            </a:r>
            <a:r>
              <a:rPr lang="en-US" sz="27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. uechtritzii)</a:t>
            </a:r>
            <a:r>
              <a:rPr lang="en-US" sz="27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picted by comprehensive LC-MS and multivariate data analysis</a:t>
            </a:r>
            <a:endParaRPr lang="it-IT" sz="2700" b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E5E85B16-8E68-4CF1-8D3A-E63B8847BF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80931" y="3111531"/>
            <a:ext cx="9144000" cy="530124"/>
          </a:xfrm>
        </p:spPr>
        <p:txBody>
          <a:bodyPr/>
          <a:lstStyle/>
          <a:p>
            <a:pPr algn="just"/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fano Dall’Acqua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*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tefania Sut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Gokhan Zengin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*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Gregorio Peron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evzi Elbasan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,5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vren Yıldıztugay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Nabeelah Bibi Sadeer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Mohamad Fawzi Mahomoodally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  <a:p>
            <a:pPr algn="just"/>
            <a:endParaRPr lang="it-IT" sz="1400" b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it-IT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B1C38552-BD77-D9D7-BF6D-1FE1E1824FEE}"/>
              </a:ext>
            </a:extLst>
          </p:cNvPr>
          <p:cNvSpPr txBox="1"/>
          <p:nvPr/>
        </p:nvSpPr>
        <p:spPr>
          <a:xfrm>
            <a:off x="-104172" y="3856681"/>
            <a:ext cx="10783747" cy="2605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656080" indent="-125730">
              <a:lnSpc>
                <a:spcPct val="150000"/>
              </a:lnSpc>
            </a:pPr>
            <a:r>
              <a:rPr lang="en-US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Pharmaceutical and Pharmacological Sciences, University of Padova, Via Marzolo 5, 35131 Padova, Italy, stefano.dallacqua@unipd.it (S.D), stefania.sut@unipd.it (S.S).</a:t>
            </a:r>
            <a:endParaRPr lang="it-IT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indent="-125730">
              <a:lnSpc>
                <a:spcPct val="150000"/>
              </a:lnSpc>
            </a:pPr>
            <a:r>
              <a:rPr lang="en-US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Biology, Science Faculty, Selcuk University, Konya, Turkey, gokhanzengin@selcuk.edu.tr (G.Z)</a:t>
            </a:r>
            <a:endParaRPr lang="it-IT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indent="-125730">
              <a:lnSpc>
                <a:spcPct val="150000"/>
              </a:lnSpc>
            </a:pPr>
            <a:r>
              <a:rPr lang="en-US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Molecular and Translational Medicine (DMMT), University of Brescia, Viale Europa 11, 25123 Brescia, Italy, gregorio.peron@unibs.it (G.P)</a:t>
            </a:r>
            <a:endParaRPr lang="it-IT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indent="-125730">
              <a:lnSpc>
                <a:spcPct val="150000"/>
              </a:lnSpc>
            </a:pPr>
            <a:r>
              <a:rPr lang="en-US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Biotechnology, Science Faculty, Selcuk University, Konya, Turkey, eytugay@selcuk.edu.tr (E.Y), fevzi.elba@gmail.com (F.E)</a:t>
            </a:r>
            <a:endParaRPr lang="it-IT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indent="-125730">
              <a:lnSpc>
                <a:spcPct val="150000"/>
              </a:lnSpc>
            </a:pPr>
            <a:r>
              <a:rPr lang="en-US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Soil Science and Plant Nutrition, Selcuk University, Konya, Turkey</a:t>
            </a:r>
            <a:endParaRPr lang="it-IT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indent="-125730">
              <a:lnSpc>
                <a:spcPct val="150000"/>
              </a:lnSpc>
            </a:pPr>
            <a:r>
              <a:rPr lang="en-US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Health Sciences, Faculty of Medicine and Health Sciences, University of Mauritius, Réduit 80837, Mauritius.  nabeelah.sadeer1@umail.uom.ac.mu (N.B.S), f.mahomoodally@uom.ac.mu (M.F.M.)</a:t>
            </a:r>
            <a:endParaRPr lang="it-IT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81810" indent="-125730">
              <a:lnSpc>
                <a:spcPct val="150000"/>
              </a:lnSpc>
            </a:pPr>
            <a:r>
              <a:rPr lang="en-US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ence: stefano.dallacqua@unipd.it ; gokhanzengin@selcuk.edu.tr</a:t>
            </a:r>
            <a:endParaRPr lang="it-IT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56442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CB62FDAD-FB56-E647-0E85-B89A6A9E32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8421276"/>
              </p:ext>
            </p:extLst>
          </p:nvPr>
        </p:nvGraphicFramePr>
        <p:xfrm>
          <a:off x="1247050" y="83293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7606A358-1CBB-4F52-A193-CAEDF168B5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8817566"/>
              </p:ext>
            </p:extLst>
          </p:nvPr>
        </p:nvGraphicFramePr>
        <p:xfrm>
          <a:off x="6376263" y="83769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062561DF-E383-4048-BEF5-FAEB5B65E4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6739561"/>
              </p:ext>
            </p:extLst>
          </p:nvPr>
        </p:nvGraphicFramePr>
        <p:xfrm>
          <a:off x="1127988" y="388569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DDB7E195-20F5-47FF-AEF8-20F7EBB28D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4986973"/>
              </p:ext>
            </p:extLst>
          </p:nvPr>
        </p:nvGraphicFramePr>
        <p:xfrm>
          <a:off x="6376263" y="388569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0EBDB411-86DB-6AE9-D8F6-0B10821D6385}"/>
              </a:ext>
            </a:extLst>
          </p:cNvPr>
          <p:cNvSpPr txBox="1"/>
          <p:nvPr/>
        </p:nvSpPr>
        <p:spPr>
          <a:xfrm>
            <a:off x="458622" y="229107"/>
            <a:ext cx="1072252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ure S1: Pie charts summarising the relative percentage of phytochemicals identified and quantified in </a:t>
            </a:r>
            <a:r>
              <a:rPr lang="it-IT" i="1" dirty="0"/>
              <a:t>P.heyniae </a:t>
            </a:r>
            <a:r>
              <a:rPr lang="it-IT" dirty="0"/>
              <a:t>extracts.</a:t>
            </a:r>
          </a:p>
          <a:p>
            <a:endParaRPr lang="it-IT" dirty="0"/>
          </a:p>
          <a:p>
            <a:endParaRPr lang="it-IT" dirty="0"/>
          </a:p>
          <a:p>
            <a:endParaRPr lang="it-IT" dirty="0"/>
          </a:p>
          <a:p>
            <a:endParaRPr lang="it-IT" dirty="0"/>
          </a:p>
          <a:p>
            <a:endParaRPr lang="it-IT" dirty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796426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AB76E6C6-A5C6-4753-870D-29FBAE8DF1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5481353"/>
              </p:ext>
            </p:extLst>
          </p:nvPr>
        </p:nvGraphicFramePr>
        <p:xfrm>
          <a:off x="1304924" y="106203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351C3AE9-475D-40AD-B7E2-94848A0A2F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1593519"/>
              </p:ext>
            </p:extLst>
          </p:nvPr>
        </p:nvGraphicFramePr>
        <p:xfrm>
          <a:off x="6434137" y="1066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7B9CCE10-AE6D-4368-812E-970E1FD000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6916555"/>
              </p:ext>
            </p:extLst>
          </p:nvPr>
        </p:nvGraphicFramePr>
        <p:xfrm>
          <a:off x="1185862" y="4114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FD502070-4B31-43B5-9C9B-7277DE60EE1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5244074"/>
              </p:ext>
            </p:extLst>
          </p:nvPr>
        </p:nvGraphicFramePr>
        <p:xfrm>
          <a:off x="6434137" y="4114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D96AFA87-C24C-83C8-64AF-2D564BD2E8BF}"/>
              </a:ext>
            </a:extLst>
          </p:cNvPr>
          <p:cNvSpPr txBox="1"/>
          <p:nvPr/>
        </p:nvSpPr>
        <p:spPr>
          <a:xfrm>
            <a:off x="458622" y="229107"/>
            <a:ext cx="1072252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ure S2: Pie charts summarising the relative percentage of phytochemicals identified and quantified in </a:t>
            </a:r>
            <a:r>
              <a:rPr lang="it-IT" i="1" dirty="0"/>
              <a:t>P.meliocarpoides </a:t>
            </a:r>
            <a:r>
              <a:rPr lang="it-IT" dirty="0"/>
              <a:t>extracts.</a:t>
            </a:r>
          </a:p>
          <a:p>
            <a:endParaRPr lang="it-IT" dirty="0"/>
          </a:p>
          <a:p>
            <a:endParaRPr lang="it-IT" dirty="0"/>
          </a:p>
          <a:p>
            <a:endParaRPr lang="it-IT" dirty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5178414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457B70D8-6574-4ADC-85E5-FBDFA0CE7D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7018237"/>
              </p:ext>
            </p:extLst>
          </p:nvPr>
        </p:nvGraphicFramePr>
        <p:xfrm>
          <a:off x="1293350" y="106203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57BDD43E-D010-4097-9286-E99B1CFF5E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4119146"/>
              </p:ext>
            </p:extLst>
          </p:nvPr>
        </p:nvGraphicFramePr>
        <p:xfrm>
          <a:off x="6422563" y="1066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2E920278-672C-4DB4-9658-A73D455D620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1265507"/>
              </p:ext>
            </p:extLst>
          </p:nvPr>
        </p:nvGraphicFramePr>
        <p:xfrm>
          <a:off x="1174288" y="4114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A38F5C66-4F95-4B9C-96F9-E098D706CA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541938"/>
              </p:ext>
            </p:extLst>
          </p:nvPr>
        </p:nvGraphicFramePr>
        <p:xfrm>
          <a:off x="6422563" y="4114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6DE34B1D-5256-E3AE-118F-F6AAA7822317}"/>
              </a:ext>
            </a:extLst>
          </p:cNvPr>
          <p:cNvSpPr txBox="1"/>
          <p:nvPr/>
        </p:nvSpPr>
        <p:spPr>
          <a:xfrm>
            <a:off x="458622" y="229107"/>
            <a:ext cx="1072252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ure S3: Pie charts summarising the relative percentage of phytochemicals identified and quantified in </a:t>
            </a:r>
            <a:r>
              <a:rPr lang="it-IT" i="1" dirty="0"/>
              <a:t>P.uechtritzii </a:t>
            </a:r>
            <a:r>
              <a:rPr lang="it-IT" dirty="0"/>
              <a:t>extracts.</a:t>
            </a:r>
          </a:p>
          <a:p>
            <a:endParaRPr lang="it-IT" dirty="0"/>
          </a:p>
          <a:p>
            <a:endParaRPr lang="it-IT" dirty="0"/>
          </a:p>
          <a:p>
            <a:endParaRPr lang="it-IT" dirty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163155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8EE5CAE8-C6E9-A9E6-AB42-89D488B69A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2167" y="1099113"/>
            <a:ext cx="6162675" cy="373380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432FA7EF-A3AB-D348-8505-2F600B4F8557}"/>
              </a:ext>
            </a:extLst>
          </p:cNvPr>
          <p:cNvSpPr txBox="1"/>
          <p:nvPr/>
        </p:nvSpPr>
        <p:spPr>
          <a:xfrm>
            <a:off x="458622" y="229107"/>
            <a:ext cx="1072252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ure S4: MSn spectra showing the loss of water and proposed fragmentation for the peak assigned to chebulic acid </a:t>
            </a:r>
          </a:p>
          <a:p>
            <a:endParaRPr lang="it-IT" dirty="0"/>
          </a:p>
          <a:p>
            <a:endParaRPr lang="it-IT" dirty="0"/>
          </a:p>
          <a:p>
            <a:endParaRPr lang="it-IT" dirty="0"/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A0AF27A1-A32B-324F-C157-926AC340D7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4335" y="1334793"/>
            <a:ext cx="2424516" cy="2424516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F80723E3-A81A-49B5-A0C7-961CA3E9EB2C}"/>
              </a:ext>
            </a:extLst>
          </p:cNvPr>
          <p:cNvSpPr txBox="1"/>
          <p:nvPr/>
        </p:nvSpPr>
        <p:spPr>
          <a:xfrm>
            <a:off x="6096000" y="2362385"/>
            <a:ext cx="165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Loss of water</a:t>
            </a:r>
          </a:p>
        </p:txBody>
      </p:sp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3999B91E-1CFE-6735-AE21-63A69632AD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0926202"/>
              </p:ext>
            </p:extLst>
          </p:nvPr>
        </p:nvGraphicFramePr>
        <p:xfrm>
          <a:off x="2347833" y="4885366"/>
          <a:ext cx="6061075" cy="15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6060775" imgH="1523684" progId="ChemDraw.Document.6.0">
                  <p:embed/>
                </p:oleObj>
              </mc:Choice>
              <mc:Fallback>
                <p:oleObj name="CS ChemDraw Drawing" r:id="rId4" imgW="6060775" imgH="152368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47833" y="4885366"/>
                        <a:ext cx="6061075" cy="15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ggetto 7">
            <a:extLst>
              <a:ext uri="{FF2B5EF4-FFF2-40B4-BE49-F238E27FC236}">
                <a16:creationId xmlns:a16="http://schemas.microsoft.com/office/drawing/2014/main" id="{B5C5CED5-9340-EB89-E1E4-B1C21263C4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8387610"/>
              </p:ext>
            </p:extLst>
          </p:nvPr>
        </p:nvGraphicFramePr>
        <p:xfrm>
          <a:off x="8920282" y="5133809"/>
          <a:ext cx="977900" cy="1027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978106" imgH="1026781" progId="ChemDraw.Document.6.0">
                  <p:embed/>
                </p:oleObj>
              </mc:Choice>
              <mc:Fallback>
                <p:oleObj name="CS ChemDraw Drawing" r:id="rId6" imgW="978106" imgH="1026781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920282" y="5133809"/>
                        <a:ext cx="977900" cy="1027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453223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9C49B354-70D3-F9E3-21F5-5C7A1B024B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4662" y="1562100"/>
            <a:ext cx="6162675" cy="3733800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7BBB379F-F17B-CA0F-EFE0-80AD782C22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186" y="1562100"/>
            <a:ext cx="2424516" cy="2424516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B60375CE-5411-CFA7-00BD-35661656B3C6}"/>
              </a:ext>
            </a:extLst>
          </p:cNvPr>
          <p:cNvSpPr txBox="1"/>
          <p:nvPr/>
        </p:nvSpPr>
        <p:spPr>
          <a:xfrm>
            <a:off x="458622" y="229107"/>
            <a:ext cx="1072252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ure S5: MSn spectra showing the loss of water and proposed fragmentation for the peak assigned to isomer of chebulic acid </a:t>
            </a:r>
          </a:p>
          <a:p>
            <a:endParaRPr lang="it-IT" dirty="0"/>
          </a:p>
          <a:p>
            <a:endParaRPr lang="it-IT" dirty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97273039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0</TotalTime>
  <Words>448</Words>
  <Application>Microsoft Office PowerPoint</Application>
  <PresentationFormat>Widescreen</PresentationFormat>
  <Paragraphs>37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Palatino Linotype</vt:lpstr>
      <vt:lpstr>Tema di Office</vt:lpstr>
      <vt:lpstr>CS ChemDraw Drawing</vt:lpstr>
      <vt:lpstr>Article Phytochemical screening, antioxidant, and enzyme inhibitory properties of three Prangos species (P. heyniae, P. meliocarpoides var. meliocarpoides and P. uechtritzii) depicted by comprehensive LC-MS and multivariate data analysi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angos</dc:title>
  <dc:creator>Dall'Acqua Stefano</dc:creator>
  <cp:lastModifiedBy>cheng hui</cp:lastModifiedBy>
  <cp:revision>18</cp:revision>
  <cp:lastPrinted>2022-05-31T09:41:26Z</cp:lastPrinted>
  <dcterms:created xsi:type="dcterms:W3CDTF">2022-02-08T21:20:18Z</dcterms:created>
  <dcterms:modified xsi:type="dcterms:W3CDTF">2022-09-01T12:17:16Z</dcterms:modified>
</cp:coreProperties>
</file>